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134959425" r:id="rId2"/>
    <p:sldId id="2134959417" r:id="rId3"/>
    <p:sldId id="2134959424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7" autoAdjust="0"/>
    <p:restoredTop sz="94660"/>
  </p:normalViewPr>
  <p:slideViewPr>
    <p:cSldViewPr snapToGrid="0">
      <p:cViewPr varScale="1">
        <p:scale>
          <a:sx n="98" d="100"/>
          <a:sy n="98" d="100"/>
        </p:scale>
        <p:origin x="90" y="40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1524C7-1FF3-4F94-A891-37A6AFAF0515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70A668-A721-4B8B-B367-28D82E82C1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9996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86F1FC-6C16-4E06-B72C-B7E362554AF6}" type="slidenum">
              <a:rPr lang="en-US" smtClean="0">
                <a:solidFill>
                  <a:prstClr val="black"/>
                </a:solidFill>
              </a:rPr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436722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86F1FC-6C16-4E06-B72C-B7E362554AF6}" type="slidenum">
              <a:rPr lang="en-US" smtClean="0">
                <a:solidFill>
                  <a:prstClr val="black"/>
                </a:solidFill>
              </a:rPr>
              <a:t>2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95341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86F1FC-6C16-4E06-B72C-B7E362554AF6}" type="slidenum">
              <a:rPr lang="en-US" smtClean="0">
                <a:solidFill>
                  <a:prstClr val="black"/>
                </a:solidFill>
              </a:rPr>
              <a:t>3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229820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175408-E0EA-7511-D071-57E2B8E885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374207-9FB2-A4A8-9454-C2EF1A3DAE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BF9203-F214-9F33-5C30-5A3660CCD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DDC8F8-C222-5465-6A69-02B85AF26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1EB483-A31D-FF31-AD05-EA4ADB25A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817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30BE80-9D6B-98D3-DD33-C01DBC3D01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23871F-28CC-ECF7-E3E0-F90ADC2904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11F3B6-F060-2795-2E5B-F3059715F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4430A-AFB7-401D-CF0A-927CF7AEC1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0C512F-17F3-9576-6963-0D74E80F4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21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7B945C-A347-88B5-0EFA-D730F92129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CECC23-4B75-6912-E11C-FFC92F4F80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D574CF-B6B7-997E-FBCD-4D8E5405C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038B97-D474-D437-C0BD-5AA2DCEBE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2CFB24-998F-4C20-4F08-2429026B2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499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C4E24A-E49C-718A-58C4-5A5F9275F0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3C5930-F4CC-24E8-E7D8-72FEAEB35F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B4AF0B-FCEF-EE29-8EC4-A92F931C1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0D62E2-D411-8ACC-DE65-19F33831A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49272E-C3FA-FCB3-113B-C9E92CD10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366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3A0405-69C6-2243-EB06-A8BDAE4128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DECACF-C21E-0704-3CCA-2FF3088F50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B9EBEF-796E-8196-AFE9-B38242528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62C1DE-22B6-B660-127A-D0B89155A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FB8288-A407-46CB-9AA7-CDD51F3D0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251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2CE74E-EFF7-1221-80D1-A03066754E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709734-BDC3-5353-2385-9A058E85E0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8F1FD1-1121-AE90-BEDF-3F2197DFFD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D78486-34C2-E6CE-E6C5-7D6DC80B9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153E18-211F-D372-D885-94F49F6CB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AF3125-C6B1-8A6A-C5FD-51B26FD7A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307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5BDA5B-1FF9-5532-B281-600B9AB72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B1229B-CD02-F26A-C1CF-648AA7C842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36F2D4-7DB0-DE81-B8D2-6AAECC42C8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BC423D-A250-5DA6-8E6E-1578A33DED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5C5218-035E-E3D8-1A0E-2442A9764F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BC10D9-B821-18D8-7A83-D7B9BED25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30499B3-EE4C-E1D0-F067-6D15516D5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5E3CA5E-28B7-E978-E656-4007026933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263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0B8283-F635-AAF3-D692-DD14BAFD55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52FD14-5873-1655-9BD5-468D567C2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52D892-A0D6-D112-8138-B8338E1DC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BBD0F2A-0563-9CC2-EF92-96692C995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259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5D68314-8B60-6DFB-CD7F-F82943D33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7BB8AF-42ED-3828-ABF1-9DB9A44DB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2BE9F7-0364-D262-F28C-9EC777847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986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E4000D-EF2D-7E5D-ED20-34A772A546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D6C889-A807-275D-5A6B-7D882C7D78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32648F-EDF4-2254-3B90-4A1D9C95D6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806CE0-76C4-CB44-F620-6B1222B11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8AD584-2F35-2D32-3F18-4D2A8A4EF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76CEDA-06A5-66FB-DEDD-16268D5BC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838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4474E-8641-84DB-9313-861775B3F3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233B52-68A1-CD53-C127-89CDF5E81D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8EE6E8-3E47-A8E6-9F37-5A3A513D0D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ECCA0E-4A7F-20FF-105A-8373BACEC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1416E3-7211-3921-17B0-14937F9098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3CA65E-3A3F-7AD9-FACB-DDF77AA12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130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E106E6-1078-B88F-6601-E5AD283985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212698-60B3-D743-E79B-739F76707F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05C053-3AA6-36DF-2A0C-3198FF91A8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F6942D-88C5-441E-B099-74951663557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CA8D64-42A3-B85F-5B62-1F3738A484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FE54A6-DA76-7209-C647-99441ADB94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4A3C06-D780-4F78-9B6E-FC29AC28E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710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DD412A4-D7AD-CAE8-DA61-176CF4FC15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0903" y="863977"/>
            <a:ext cx="9247257" cy="591852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697CAE9-FDE8-004F-4E20-7E2CA4D878A6}"/>
              </a:ext>
            </a:extLst>
          </p:cNvPr>
          <p:cNvSpPr txBox="1"/>
          <p:nvPr/>
        </p:nvSpPr>
        <p:spPr>
          <a:xfrm>
            <a:off x="251669" y="75502"/>
            <a:ext cx="1140063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l Figure S1: Heatmap of Mouse mRNA expression of NRs. The color gradient from red to blue indicates high to low expression levels. The X-axis represents the NR name, and the Y-axis shows the tissues where the expression is noted</a:t>
            </a:r>
          </a:p>
        </p:txBody>
      </p:sp>
    </p:spTree>
    <p:extLst>
      <p:ext uri="{BB962C8B-B14F-4D97-AF65-F5344CB8AC3E}">
        <p14:creationId xmlns:p14="http://schemas.microsoft.com/office/powerpoint/2010/main" val="25777191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ED796D1-0DAA-1564-1900-8CEEB82818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5677" y="991283"/>
            <a:ext cx="9431165" cy="521512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1F38A67-ADC6-E3BB-21D7-E9D7734EE01B}"/>
              </a:ext>
            </a:extLst>
          </p:cNvPr>
          <p:cNvSpPr txBox="1"/>
          <p:nvPr/>
        </p:nvSpPr>
        <p:spPr>
          <a:xfrm>
            <a:off x="192947" y="0"/>
            <a:ext cx="1192441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l Figure S2: Heatmap of Dog mRNA expression of NRs. The color gradient from red to blue indicates high to low expression levels. The X-axis represents the NR name, and the Y-axis shows the tissues where the expression is noted</a:t>
            </a:r>
          </a:p>
        </p:txBody>
      </p:sp>
    </p:spTree>
    <p:extLst>
      <p:ext uri="{BB962C8B-B14F-4D97-AF65-F5344CB8AC3E}">
        <p14:creationId xmlns:p14="http://schemas.microsoft.com/office/powerpoint/2010/main" val="40350856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AA372D6-8B9F-5D71-4946-271D2BB6BE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5735" y="1056802"/>
            <a:ext cx="8973054" cy="567889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564E3C4-E13A-AFEF-2483-98CB33B62171}"/>
              </a:ext>
            </a:extLst>
          </p:cNvPr>
          <p:cNvSpPr txBox="1"/>
          <p:nvPr/>
        </p:nvSpPr>
        <p:spPr>
          <a:xfrm>
            <a:off x="310393" y="122306"/>
            <a:ext cx="1140902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l </a:t>
            </a:r>
            <a:r>
              <a:rPr lang="en-US" b="1"/>
              <a:t>Figure S3</a:t>
            </a:r>
            <a:r>
              <a:rPr lang="en-US" b="1" dirty="0"/>
              <a:t>: Heatmap of Cynomolgus monkey mRNA expression of NRs. The color gradient from red to blue indicates high to low expression levels. The X-axis represents the NR name, and the Y-axis shows the tissues where the expression is noted</a:t>
            </a:r>
          </a:p>
        </p:txBody>
      </p:sp>
    </p:spTree>
    <p:extLst>
      <p:ext uri="{BB962C8B-B14F-4D97-AF65-F5344CB8AC3E}">
        <p14:creationId xmlns:p14="http://schemas.microsoft.com/office/powerpoint/2010/main" val="1845024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496</TotalTime>
  <Words>136</Words>
  <Application>Microsoft Office PowerPoint</Application>
  <PresentationFormat>Widescreen</PresentationFormat>
  <Paragraphs>6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Neurocrine Bioscien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n Rao</dc:creator>
  <cp:lastModifiedBy>Mohan Rao</cp:lastModifiedBy>
  <cp:revision>12</cp:revision>
  <dcterms:created xsi:type="dcterms:W3CDTF">2023-06-07T16:53:48Z</dcterms:created>
  <dcterms:modified xsi:type="dcterms:W3CDTF">2024-07-02T13:13:25Z</dcterms:modified>
</cp:coreProperties>
</file>